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winserver16\data\mdcrc\Research%20Server%20Main\NGS%20MDCRC\Data\961%20unrelated\Rough\NGS%20consolidation%20-%20proband%20paper%20-%2096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07206412476443"/>
          <c:y val="4.1467073920875321E-2"/>
          <c:w val="0.79193072857594049"/>
          <c:h val="0.7449387962031602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NGS - DMD'!$T$72</c:f>
              <c:strCache>
                <c:ptCount val="1"/>
                <c:pt idx="0">
                  <c:v>5'bp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NGS - DMD'!$S$73:$S$76</c:f>
              <c:strCache>
                <c:ptCount val="4"/>
                <c:pt idx="0">
                  <c:v>Frameshift </c:v>
                </c:pt>
                <c:pt idx="1">
                  <c:v>Splice site</c:v>
                </c:pt>
                <c:pt idx="2">
                  <c:v>Missense</c:v>
                </c:pt>
                <c:pt idx="3">
                  <c:v>Nonsense</c:v>
                </c:pt>
              </c:strCache>
            </c:strRef>
          </c:cat>
          <c:val>
            <c:numRef>
              <c:f>'NGS - DMD'!$T$73:$T$76</c:f>
              <c:numCache>
                <c:formatCode>General</c:formatCode>
                <c:ptCount val="4"/>
                <c:pt idx="1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FC-4E7E-ACF8-CEE253D51FD9}"/>
            </c:ext>
          </c:extLst>
        </c:ser>
        <c:ser>
          <c:idx val="1"/>
          <c:order val="1"/>
          <c:tx>
            <c:strRef>
              <c:f>'NGS - DMD'!$U$72</c:f>
              <c:strCache>
                <c:ptCount val="1"/>
                <c:pt idx="0">
                  <c:v>3'bp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NGS - DMD'!$S$73:$S$76</c:f>
              <c:strCache>
                <c:ptCount val="4"/>
                <c:pt idx="0">
                  <c:v>Frameshift </c:v>
                </c:pt>
                <c:pt idx="1">
                  <c:v>Splice site</c:v>
                </c:pt>
                <c:pt idx="2">
                  <c:v>Missense</c:v>
                </c:pt>
                <c:pt idx="3">
                  <c:v>Nonsense</c:v>
                </c:pt>
              </c:strCache>
            </c:strRef>
          </c:cat>
          <c:val>
            <c:numRef>
              <c:f>'NGS - DMD'!$U$73:$U$76</c:f>
              <c:numCache>
                <c:formatCode>General</c:formatCode>
                <c:ptCount val="4"/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FC-4E7E-ACF8-CEE253D51FD9}"/>
            </c:ext>
          </c:extLst>
        </c:ser>
        <c:ser>
          <c:idx val="2"/>
          <c:order val="2"/>
          <c:tx>
            <c:strRef>
              <c:f>'NGS - DMD'!$V$72</c:f>
              <c:strCache>
                <c:ptCount val="1"/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438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6FC-4E7E-ACF8-CEE253D51FD9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6FC-4E7E-ACF8-CEE253D51FD9}"/>
              </c:ext>
            </c:extLst>
          </c:dPt>
          <c:dPt>
            <c:idx val="3"/>
            <c:invertIfNegative val="0"/>
            <c:bubble3D val="0"/>
            <c:spPr>
              <a:solidFill>
                <a:srgbClr val="99CC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6FC-4E7E-ACF8-CEE253D51FD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NGS - DMD'!$S$73:$S$76</c:f>
              <c:strCache>
                <c:ptCount val="4"/>
                <c:pt idx="0">
                  <c:v>Frameshift </c:v>
                </c:pt>
                <c:pt idx="1">
                  <c:v>Splice site</c:v>
                </c:pt>
                <c:pt idx="2">
                  <c:v>Missense</c:v>
                </c:pt>
                <c:pt idx="3">
                  <c:v>Nonsense</c:v>
                </c:pt>
              </c:strCache>
            </c:strRef>
          </c:cat>
          <c:val>
            <c:numRef>
              <c:f>'NGS - DMD'!$V$73:$V$76</c:f>
              <c:numCache>
                <c:formatCode>General</c:formatCode>
                <c:ptCount val="4"/>
                <c:pt idx="0">
                  <c:v>30</c:v>
                </c:pt>
                <c:pt idx="2">
                  <c:v>4</c:v>
                </c:pt>
                <c:pt idx="3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6FC-4E7E-ACF8-CEE253D51F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5"/>
        <c:overlap val="100"/>
        <c:axId val="136668288"/>
        <c:axId val="136670592"/>
      </c:barChart>
      <c:catAx>
        <c:axId val="136668288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200"/>
                </a:pPr>
                <a:r>
                  <a:rPr lang="en-IN" sz="1200"/>
                  <a:t>Types of mutation</a:t>
                </a:r>
              </a:p>
            </c:rich>
          </c:tx>
          <c:layout>
            <c:manualLayout>
              <c:xMode val="edge"/>
              <c:yMode val="edge"/>
              <c:x val="0.44196767935128456"/>
              <c:y val="0.888748975384421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6670592"/>
        <c:crosses val="autoZero"/>
        <c:auto val="1"/>
        <c:lblAlgn val="ctr"/>
        <c:lblOffset val="100"/>
        <c:noMultiLvlLbl val="0"/>
      </c:catAx>
      <c:valAx>
        <c:axId val="136670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IN" sz="1400"/>
                  <a:t>No.of patients</a:t>
                </a:r>
              </a:p>
            </c:rich>
          </c:tx>
          <c:layout>
            <c:manualLayout>
              <c:xMode val="edge"/>
              <c:yMode val="edge"/>
              <c:x val="9.8794704603833248E-3"/>
              <c:y val="0.2919780229887363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6668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delete val="1"/>
      </c:legendEntry>
      <c:layout/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1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77737" y="1130779"/>
            <a:ext cx="7178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2 Fig: Types of mutations found in 94 DMD patients analysed by NGS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2855724516"/>
              </p:ext>
            </p:extLst>
          </p:nvPr>
        </p:nvGraphicFramePr>
        <p:xfrm>
          <a:off x="2577737" y="2011679"/>
          <a:ext cx="7071360" cy="3587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63344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5</cp:revision>
  <dcterms:created xsi:type="dcterms:W3CDTF">2020-01-14T07:41:46Z</dcterms:created>
  <dcterms:modified xsi:type="dcterms:W3CDTF">2020-01-14T07:45:05Z</dcterms:modified>
</cp:coreProperties>
</file>